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02B769-E198-4449-BDF2-5791D1888CE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25E3CB-BDA8-46B9-8C94-8FDE175B6C2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DC34EE-23BE-4377-9814-8B37996F575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98578D-6A06-4E37-99A8-94B51CD1648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AC37DE-1A35-4688-9BC1-69AB0DF409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3831C3-5D6C-40D5-A96B-62875CEE92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60EACC-3911-4904-B828-86E1BDD40D8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7BAAB4-4428-4CE0-BC6B-D7BFEBC138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F09084-C444-40E9-B02A-EC88FD4F551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715D5F-E718-4BA4-903E-BD5A5AAC44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D48F71-5F4A-43DA-9526-D4F613FCDC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F487F4-0D9D-49C7-8578-EABB31D41B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800D7C2-5360-41E1-8F46-284624FDEF3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" descr=""/>
          <p:cNvPicPr/>
          <p:nvPr/>
        </p:nvPicPr>
        <p:blipFill>
          <a:blip r:embed="rId1"/>
          <a:stretch/>
        </p:blipFill>
        <p:spPr>
          <a:xfrm>
            <a:off x="1954080" y="826920"/>
            <a:ext cx="3996000" cy="259272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2" descr=""/>
          <p:cNvPicPr/>
          <p:nvPr/>
        </p:nvPicPr>
        <p:blipFill>
          <a:blip r:embed="rId2"/>
          <a:stretch/>
        </p:blipFill>
        <p:spPr>
          <a:xfrm>
            <a:off x="1989000" y="4140360"/>
            <a:ext cx="3996000" cy="259236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675000" y="847800"/>
            <a:ext cx="38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694080" y="4133880"/>
            <a:ext cx="38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20960" y="7400880"/>
            <a:ext cx="674316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Supplementary Figure: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 Drug-dependent time courses of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buClr>
                <a:srgbClr val="000000"/>
              </a:buClr>
              <a:buFont typeface="Arial"/>
              <a:buAutoNum type="alphaLcParenR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ALAT (drug type X time: p=0.069),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buClr>
                <a:srgbClr val="000000"/>
              </a:buClr>
              <a:buFont typeface="Arial"/>
              <a:buAutoNum type="alphaLcParenR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ASAT (drug type X time: p=0.129).</a:t>
            </a: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4-03-27T11:36:01Z</dcterms:created>
  <dc:creator>Johann Steiner</dc:creator>
  <dc:description/>
  <dc:language>en-US</dc:language>
  <cp:lastModifiedBy>Johann Steiner</cp:lastModifiedBy>
  <dcterms:modified xsi:type="dcterms:W3CDTF">2024-03-27T11:39:16Z</dcterms:modified>
  <cp:revision>1</cp:revision>
  <dc:subject/>
  <dc:title>Folie 1</dc:title>
</cp:coreProperties>
</file>